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5"/>
  </p:notesMasterIdLst>
  <p:sldIdLst>
    <p:sldId id="259" r:id="rId2"/>
    <p:sldId id="283" r:id="rId3"/>
    <p:sldId id="272" r:id="rId4"/>
  </p:sldIdLst>
  <p:sldSz cx="7315200" cy="100584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747775"/>
          </p15:clr>
        </p15:guide>
        <p15:guide id="2" pos="2304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47F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976"/>
    <p:restoredTop sz="93935"/>
  </p:normalViewPr>
  <p:slideViewPr>
    <p:cSldViewPr snapToGrid="0">
      <p:cViewPr varScale="1">
        <p:scale>
          <a:sx n="75" d="100"/>
          <a:sy n="75" d="100"/>
        </p:scale>
        <p:origin x="3016" y="160"/>
      </p:cViewPr>
      <p:guideLst>
        <p:guide orient="horz" pos="3168"/>
        <p:guide pos="23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ncarkolinski@gmail.com" userId="S::urn:spo:guest#alencarkolinski@gmail.com::" providerId="AD" clId="Web-{D68D7061-1502-0D52-53CA-97B814E4113E}"/>
    <pc:docChg chg="modSld">
      <pc:chgData name="alencarkolinski@gmail.com" userId="S::urn:spo:guest#alencarkolinski@gmail.com::" providerId="AD" clId="Web-{D68D7061-1502-0D52-53CA-97B814E4113E}" dt="2025-01-24T13:21:54.015" v="97" actId="20577"/>
      <pc:docMkLst>
        <pc:docMk/>
      </pc:docMkLst>
      <pc:sldChg chg="modSp">
        <pc:chgData name="alencarkolinski@gmail.com" userId="S::urn:spo:guest#alencarkolinski@gmail.com::" providerId="AD" clId="Web-{D68D7061-1502-0D52-53CA-97B814E4113E}" dt="2025-01-24T13:21:54.015" v="97" actId="20577"/>
        <pc:sldMkLst>
          <pc:docMk/>
          <pc:sldMk cId="0" sldId="273"/>
        </pc:sldMkLst>
      </pc:sldChg>
    </pc:docChg>
  </pc:docChgLst>
  <pc:docChgLst>
    <pc:chgData name="Dana El Soufi El Sabbagh" userId="74de5ba5-1dc9-4933-9dda-791d435de68e" providerId="ADAL" clId="{C7132937-E06A-674B-82E4-943B3BB56F69}"/>
    <pc:docChg chg="undo custSel modSld">
      <pc:chgData name="Dana El Soufi El Sabbagh" userId="74de5ba5-1dc9-4933-9dda-791d435de68e" providerId="ADAL" clId="{C7132937-E06A-674B-82E4-943B3BB56F69}" dt="2025-07-14T17:35:11.281" v="223" actId="478"/>
      <pc:docMkLst>
        <pc:docMk/>
      </pc:docMkLst>
      <pc:sldChg chg="delSp mod">
        <pc:chgData name="Dana El Soufi El Sabbagh" userId="74de5ba5-1dc9-4933-9dda-791d435de68e" providerId="ADAL" clId="{C7132937-E06A-674B-82E4-943B3BB56F69}" dt="2025-07-14T17:34:56.037" v="222" actId="478"/>
        <pc:sldMkLst>
          <pc:docMk/>
          <pc:sldMk cId="0" sldId="258"/>
        </pc:sldMkLst>
        <pc:spChg chg="del">
          <ac:chgData name="Dana El Soufi El Sabbagh" userId="74de5ba5-1dc9-4933-9dda-791d435de68e" providerId="ADAL" clId="{C7132937-E06A-674B-82E4-943B3BB56F69}" dt="2025-07-14T17:34:56.037" v="222" actId="478"/>
          <ac:spMkLst>
            <pc:docMk/>
            <pc:sldMk cId="0" sldId="258"/>
            <ac:spMk id="68" creationId="{00000000-0000-0000-0000-000000000000}"/>
          </ac:spMkLst>
        </pc:spChg>
      </pc:sldChg>
      <pc:sldChg chg="modSp mod">
        <pc:chgData name="Dana El Soufi El Sabbagh" userId="74de5ba5-1dc9-4933-9dda-791d435de68e" providerId="ADAL" clId="{C7132937-E06A-674B-82E4-943B3BB56F69}" dt="2025-06-30T18:01:24.890" v="221" actId="20577"/>
        <pc:sldMkLst>
          <pc:docMk/>
          <pc:sldMk cId="0" sldId="266"/>
        </pc:sldMkLst>
      </pc:sldChg>
      <pc:sldChg chg="addSp modSp mod">
        <pc:chgData name="Dana El Soufi El Sabbagh" userId="74de5ba5-1dc9-4933-9dda-791d435de68e" providerId="ADAL" clId="{C7132937-E06A-674B-82E4-943B3BB56F69}" dt="2025-06-30T17:12:14.918" v="173" actId="14100"/>
        <pc:sldMkLst>
          <pc:docMk/>
          <pc:sldMk cId="1544026710" sldId="274"/>
        </pc:sldMkLst>
      </pc:sldChg>
      <pc:sldChg chg="addSp delSp modSp mod">
        <pc:chgData name="Dana El Soufi El Sabbagh" userId="74de5ba5-1dc9-4933-9dda-791d435de68e" providerId="ADAL" clId="{C7132937-E06A-674B-82E4-943B3BB56F69}" dt="2025-06-30T17:12:37.983" v="177" actId="1076"/>
        <pc:sldMkLst>
          <pc:docMk/>
          <pc:sldMk cId="1609219018" sldId="275"/>
        </pc:sldMkLst>
      </pc:sldChg>
      <pc:sldChg chg="modSp mod">
        <pc:chgData name="Dana El Soufi El Sabbagh" userId="74de5ba5-1dc9-4933-9dda-791d435de68e" providerId="ADAL" clId="{C7132937-E06A-674B-82E4-943B3BB56F69}" dt="2025-06-30T17:21:11.137" v="189" actId="20577"/>
        <pc:sldMkLst>
          <pc:docMk/>
          <pc:sldMk cId="3281206061" sldId="276"/>
        </pc:sldMkLst>
      </pc:sldChg>
      <pc:sldChg chg="delSp mod">
        <pc:chgData name="Dana El Soufi El Sabbagh" userId="74de5ba5-1dc9-4933-9dda-791d435de68e" providerId="ADAL" clId="{C7132937-E06A-674B-82E4-943B3BB56F69}" dt="2025-07-14T17:35:11.281" v="223" actId="478"/>
        <pc:sldMkLst>
          <pc:docMk/>
          <pc:sldMk cId="3405084103" sldId="282"/>
        </pc:sldMkLst>
        <pc:spChg chg="del">
          <ac:chgData name="Dana El Soufi El Sabbagh" userId="74de5ba5-1dc9-4933-9dda-791d435de68e" providerId="ADAL" clId="{C7132937-E06A-674B-82E4-943B3BB56F69}" dt="2025-07-14T17:35:11.281" v="223" actId="478"/>
          <ac:spMkLst>
            <pc:docMk/>
            <pc:sldMk cId="3405084103" sldId="282"/>
            <ac:spMk id="109" creationId="{1B95A027-6E84-A86C-F56F-C41A99D71FC7}"/>
          </ac:spMkLst>
        </pc:spChg>
      </pc:sldChg>
    </pc:docChg>
  </pc:docChgLst>
  <pc:docChgLst>
    <pc:chgData name="Dana El Soufi El Sabbagh" userId="74de5ba5-1dc9-4933-9dda-791d435de68e" providerId="ADAL" clId="{FC98A1AC-78BA-F34B-A110-9F5719739F8C}"/>
    <pc:docChg chg="delSld">
      <pc:chgData name="Dana El Soufi El Sabbagh" userId="74de5ba5-1dc9-4933-9dda-791d435de68e" providerId="ADAL" clId="{FC98A1AC-78BA-F34B-A110-9F5719739F8C}" dt="2025-07-14T17:57:28.505" v="11" actId="2696"/>
      <pc:docMkLst>
        <pc:docMk/>
      </pc:docMkLst>
      <pc:sldChg chg="del">
        <pc:chgData name="Dana El Soufi El Sabbagh" userId="74de5ba5-1dc9-4933-9dda-791d435de68e" providerId="ADAL" clId="{FC98A1AC-78BA-F34B-A110-9F5719739F8C}" dt="2025-07-14T17:57:24.141" v="0" actId="2696"/>
        <pc:sldMkLst>
          <pc:docMk/>
          <pc:sldMk cId="0" sldId="258"/>
        </pc:sldMkLst>
      </pc:sldChg>
      <pc:sldChg chg="del">
        <pc:chgData name="Dana El Soufi El Sabbagh" userId="74de5ba5-1dc9-4933-9dda-791d435de68e" providerId="ADAL" clId="{FC98A1AC-78BA-F34B-A110-9F5719739F8C}" dt="2025-07-14T17:57:25.521" v="3" actId="2696"/>
        <pc:sldMkLst>
          <pc:docMk/>
          <pc:sldMk cId="0" sldId="263"/>
        </pc:sldMkLst>
      </pc:sldChg>
      <pc:sldChg chg="del">
        <pc:chgData name="Dana El Soufi El Sabbagh" userId="74de5ba5-1dc9-4933-9dda-791d435de68e" providerId="ADAL" clId="{FC98A1AC-78BA-F34B-A110-9F5719739F8C}" dt="2025-07-14T17:57:26.526" v="6" actId="2696"/>
        <pc:sldMkLst>
          <pc:docMk/>
          <pc:sldMk cId="0" sldId="266"/>
        </pc:sldMkLst>
      </pc:sldChg>
      <pc:sldChg chg="del">
        <pc:chgData name="Dana El Soufi El Sabbagh" userId="74de5ba5-1dc9-4933-9dda-791d435de68e" providerId="ADAL" clId="{FC98A1AC-78BA-F34B-A110-9F5719739F8C}" dt="2025-07-14T17:57:27.218" v="8" actId="2696"/>
        <pc:sldMkLst>
          <pc:docMk/>
          <pc:sldMk cId="0" sldId="270"/>
        </pc:sldMkLst>
      </pc:sldChg>
      <pc:sldChg chg="del">
        <pc:chgData name="Dana El Soufi El Sabbagh" userId="74de5ba5-1dc9-4933-9dda-791d435de68e" providerId="ADAL" clId="{FC98A1AC-78BA-F34B-A110-9F5719739F8C}" dt="2025-07-14T17:57:25.733" v="4" actId="2696"/>
        <pc:sldMkLst>
          <pc:docMk/>
          <pc:sldMk cId="1544026710" sldId="274"/>
        </pc:sldMkLst>
      </pc:sldChg>
      <pc:sldChg chg="del">
        <pc:chgData name="Dana El Soufi El Sabbagh" userId="74de5ba5-1dc9-4933-9dda-791d435de68e" providerId="ADAL" clId="{FC98A1AC-78BA-F34B-A110-9F5719739F8C}" dt="2025-07-14T17:57:26.130" v="5" actId="2696"/>
        <pc:sldMkLst>
          <pc:docMk/>
          <pc:sldMk cId="1609219018" sldId="275"/>
        </pc:sldMkLst>
      </pc:sldChg>
      <pc:sldChg chg="del">
        <pc:chgData name="Dana El Soufi El Sabbagh" userId="74de5ba5-1dc9-4933-9dda-791d435de68e" providerId="ADAL" clId="{FC98A1AC-78BA-F34B-A110-9F5719739F8C}" dt="2025-07-14T17:57:26.887" v="7" actId="2696"/>
        <pc:sldMkLst>
          <pc:docMk/>
          <pc:sldMk cId="3281206061" sldId="276"/>
        </pc:sldMkLst>
      </pc:sldChg>
      <pc:sldChg chg="del">
        <pc:chgData name="Dana El Soufi El Sabbagh" userId="74de5ba5-1dc9-4933-9dda-791d435de68e" providerId="ADAL" clId="{FC98A1AC-78BA-F34B-A110-9F5719739F8C}" dt="2025-07-14T17:57:24.929" v="2" actId="2696"/>
        <pc:sldMkLst>
          <pc:docMk/>
          <pc:sldMk cId="1056035362" sldId="281"/>
        </pc:sldMkLst>
      </pc:sldChg>
      <pc:sldChg chg="del">
        <pc:chgData name="Dana El Soufi El Sabbagh" userId="74de5ba5-1dc9-4933-9dda-791d435de68e" providerId="ADAL" clId="{FC98A1AC-78BA-F34B-A110-9F5719739F8C}" dt="2025-07-14T17:57:24.535" v="1" actId="2696"/>
        <pc:sldMkLst>
          <pc:docMk/>
          <pc:sldMk cId="3405084103" sldId="282"/>
        </pc:sldMkLst>
      </pc:sldChg>
      <pc:sldChg chg="del">
        <pc:chgData name="Dana El Soufi El Sabbagh" userId="74de5ba5-1dc9-4933-9dda-791d435de68e" providerId="ADAL" clId="{FC98A1AC-78BA-F34B-A110-9F5719739F8C}" dt="2025-07-14T17:57:28.124" v="10" actId="2696"/>
        <pc:sldMkLst>
          <pc:docMk/>
          <pc:sldMk cId="1477581426" sldId="286"/>
        </pc:sldMkLst>
      </pc:sldChg>
      <pc:sldChg chg="del">
        <pc:chgData name="Dana El Soufi El Sabbagh" userId="74de5ba5-1dc9-4933-9dda-791d435de68e" providerId="ADAL" clId="{FC98A1AC-78BA-F34B-A110-9F5719739F8C}" dt="2025-07-14T17:57:28.505" v="11" actId="2696"/>
        <pc:sldMkLst>
          <pc:docMk/>
          <pc:sldMk cId="3070820528" sldId="288"/>
        </pc:sldMkLst>
      </pc:sldChg>
      <pc:sldChg chg="del">
        <pc:chgData name="Dana El Soufi El Sabbagh" userId="74de5ba5-1dc9-4933-9dda-791d435de68e" providerId="ADAL" clId="{FC98A1AC-78BA-F34B-A110-9F5719739F8C}" dt="2025-07-14T17:57:27.748" v="9" actId="2696"/>
        <pc:sldMkLst>
          <pc:docMk/>
          <pc:sldMk cId="795776442" sldId="289"/>
        </pc:sldMkLst>
      </pc:sldChg>
    </pc:docChg>
  </pc:docChgLst>
  <pc:docChgLst>
    <pc:chgData name="Dana El Soufi El Sabbagh" userId="74de5ba5-1dc9-4933-9dda-791d435de68e" providerId="ADAL" clId="{1042A9DD-6DD8-8142-95EA-EF1410A7106A}"/>
    <pc:docChg chg="undo custSel addSld delSld modSld">
      <pc:chgData name="Dana El Soufi El Sabbagh" userId="74de5ba5-1dc9-4933-9dda-791d435de68e" providerId="ADAL" clId="{1042A9DD-6DD8-8142-95EA-EF1410A7106A}" dt="2025-01-24T22:29:32.759" v="2251" actId="732"/>
      <pc:docMkLst>
        <pc:docMk/>
      </pc:docMkLst>
      <pc:sldChg chg="mod modShow">
        <pc:chgData name="Dana El Soufi El Sabbagh" userId="74de5ba5-1dc9-4933-9dda-791d435de68e" providerId="ADAL" clId="{1042A9DD-6DD8-8142-95EA-EF1410A7106A}" dt="2025-01-22T02:12:19.275" v="1869" actId="729"/>
        <pc:sldMkLst>
          <pc:docMk/>
          <pc:sldMk cId="0" sldId="257"/>
        </pc:sldMkLst>
      </pc:sldChg>
      <pc:sldChg chg="mod modShow">
        <pc:chgData name="Dana El Soufi El Sabbagh" userId="74de5ba5-1dc9-4933-9dda-791d435de68e" providerId="ADAL" clId="{1042A9DD-6DD8-8142-95EA-EF1410A7106A}" dt="2025-01-22T02:12:16.548" v="1868" actId="729"/>
        <pc:sldMkLst>
          <pc:docMk/>
          <pc:sldMk cId="0" sldId="258"/>
        </pc:sldMkLst>
      </pc:sldChg>
      <pc:sldChg chg="modSp mod modShow modNotesTx">
        <pc:chgData name="Dana El Soufi El Sabbagh" userId="74de5ba5-1dc9-4933-9dda-791d435de68e" providerId="ADAL" clId="{1042A9DD-6DD8-8142-95EA-EF1410A7106A}" dt="2025-01-24T22:29:32.759" v="2251" actId="732"/>
        <pc:sldMkLst>
          <pc:docMk/>
          <pc:sldMk cId="0" sldId="259"/>
        </pc:sldMkLst>
      </pc:sldChg>
      <pc:sldChg chg="addSp delSp modSp mod modShow">
        <pc:chgData name="Dana El Soufi El Sabbagh" userId="74de5ba5-1dc9-4933-9dda-791d435de68e" providerId="ADAL" clId="{1042A9DD-6DD8-8142-95EA-EF1410A7106A}" dt="2025-01-22T21:38:54.746" v="1882" actId="1076"/>
        <pc:sldMkLst>
          <pc:docMk/>
          <pc:sldMk cId="0" sldId="262"/>
        </pc:sldMkLst>
      </pc:sldChg>
      <pc:sldChg chg="addSp delSp modSp mod modShow">
        <pc:chgData name="Dana El Soufi El Sabbagh" userId="74de5ba5-1dc9-4933-9dda-791d435de68e" providerId="ADAL" clId="{1042A9DD-6DD8-8142-95EA-EF1410A7106A}" dt="2025-01-24T22:29:15.047" v="2249" actId="1076"/>
        <pc:sldMkLst>
          <pc:docMk/>
          <pc:sldMk cId="0" sldId="263"/>
        </pc:sldMkLst>
      </pc:sldChg>
      <pc:sldChg chg="del">
        <pc:chgData name="Dana El Soufi El Sabbagh" userId="74de5ba5-1dc9-4933-9dda-791d435de68e" providerId="ADAL" clId="{1042A9DD-6DD8-8142-95EA-EF1410A7106A}" dt="2025-01-21T19:02:47.981" v="210" actId="2696"/>
        <pc:sldMkLst>
          <pc:docMk/>
          <pc:sldMk cId="0" sldId="264"/>
        </pc:sldMkLst>
      </pc:sldChg>
      <pc:sldChg chg="modSp del mod">
        <pc:chgData name="Dana El Soufi El Sabbagh" userId="74de5ba5-1dc9-4933-9dda-791d435de68e" providerId="ADAL" clId="{1042A9DD-6DD8-8142-95EA-EF1410A7106A}" dt="2025-01-21T19:44:24.302" v="485" actId="2696"/>
        <pc:sldMkLst>
          <pc:docMk/>
          <pc:sldMk cId="0" sldId="265"/>
        </pc:sldMkLst>
      </pc:sldChg>
      <pc:sldChg chg="addSp modSp mod modShow">
        <pc:chgData name="Dana El Soufi El Sabbagh" userId="74de5ba5-1dc9-4933-9dda-791d435de68e" providerId="ADAL" clId="{1042A9DD-6DD8-8142-95EA-EF1410A7106A}" dt="2025-01-24T20:57:24.342" v="2233" actId="20577"/>
        <pc:sldMkLst>
          <pc:docMk/>
          <pc:sldMk cId="0" sldId="266"/>
        </pc:sldMkLst>
      </pc:sldChg>
      <pc:sldChg chg="addSp modSp del mod">
        <pc:chgData name="Dana El Soufi El Sabbagh" userId="74de5ba5-1dc9-4933-9dda-791d435de68e" providerId="ADAL" clId="{1042A9DD-6DD8-8142-95EA-EF1410A7106A}" dt="2025-01-22T02:05:04.299" v="1801" actId="2696"/>
        <pc:sldMkLst>
          <pc:docMk/>
          <pc:sldMk cId="0" sldId="267"/>
        </pc:sldMkLst>
      </pc:sldChg>
      <pc:sldChg chg="modSp del mod modShow">
        <pc:chgData name="Dana El Soufi El Sabbagh" userId="74de5ba5-1dc9-4933-9dda-791d435de68e" providerId="ADAL" clId="{1042A9DD-6DD8-8142-95EA-EF1410A7106A}" dt="2025-01-24T20:06:35.603" v="1903" actId="2696"/>
        <pc:sldMkLst>
          <pc:docMk/>
          <pc:sldMk cId="0" sldId="268"/>
        </pc:sldMkLst>
      </pc:sldChg>
      <pc:sldChg chg="addSp modSp del mod">
        <pc:chgData name="Dana El Soufi El Sabbagh" userId="74de5ba5-1dc9-4933-9dda-791d435de68e" providerId="ADAL" clId="{1042A9DD-6DD8-8142-95EA-EF1410A7106A}" dt="2025-01-22T01:23:32.286" v="1386" actId="2696"/>
        <pc:sldMkLst>
          <pc:docMk/>
          <pc:sldMk cId="0" sldId="269"/>
        </pc:sldMkLst>
      </pc:sldChg>
      <pc:sldChg chg="addSp delSp modSp mod">
        <pc:chgData name="Dana El Soufi El Sabbagh" userId="74de5ba5-1dc9-4933-9dda-791d435de68e" providerId="ADAL" clId="{1042A9DD-6DD8-8142-95EA-EF1410A7106A}" dt="2025-01-24T20:05:32.323" v="1902" actId="20577"/>
        <pc:sldMkLst>
          <pc:docMk/>
          <pc:sldMk cId="0" sldId="270"/>
        </pc:sldMkLst>
      </pc:sldChg>
      <pc:sldChg chg="addSp delSp modSp mod">
        <pc:chgData name="Dana El Soufi El Sabbagh" userId="74de5ba5-1dc9-4933-9dda-791d435de68e" providerId="ADAL" clId="{1042A9DD-6DD8-8142-95EA-EF1410A7106A}" dt="2025-01-22T01:25:11.208" v="1570" actId="1076"/>
        <pc:sldMkLst>
          <pc:docMk/>
          <pc:sldMk cId="0" sldId="271"/>
        </pc:sldMkLst>
      </pc:sldChg>
      <pc:sldChg chg="addSp delSp modSp mod">
        <pc:chgData name="Dana El Soufi El Sabbagh" userId="74de5ba5-1dc9-4933-9dda-791d435de68e" providerId="ADAL" clId="{1042A9DD-6DD8-8142-95EA-EF1410A7106A}" dt="2025-01-22T00:48:32.547" v="1176" actId="313"/>
        <pc:sldMkLst>
          <pc:docMk/>
          <pc:sldMk cId="0" sldId="272"/>
        </pc:sldMkLst>
      </pc:sldChg>
      <pc:sldChg chg="modSp mod">
        <pc:chgData name="Dana El Soufi El Sabbagh" userId="74de5ba5-1dc9-4933-9dda-791d435de68e" providerId="ADAL" clId="{1042A9DD-6DD8-8142-95EA-EF1410A7106A}" dt="2025-01-22T01:24:37.855" v="1559" actId="313"/>
        <pc:sldMkLst>
          <pc:docMk/>
          <pc:sldMk cId="0" sldId="273"/>
        </pc:sldMkLst>
      </pc:sldChg>
      <pc:sldChg chg="addSp delSp modSp new mod modShow">
        <pc:chgData name="Dana El Soufi El Sabbagh" userId="74de5ba5-1dc9-4933-9dda-791d435de68e" providerId="ADAL" clId="{1042A9DD-6DD8-8142-95EA-EF1410A7106A}" dt="2025-01-22T21:40:14.222" v="1899" actId="1076"/>
        <pc:sldMkLst>
          <pc:docMk/>
          <pc:sldMk cId="1544026710" sldId="274"/>
        </pc:sldMkLst>
      </pc:sldChg>
      <pc:sldChg chg="addSp delSp modSp add mod modShow">
        <pc:chgData name="Dana El Soufi El Sabbagh" userId="74de5ba5-1dc9-4933-9dda-791d435de68e" providerId="ADAL" clId="{1042A9DD-6DD8-8142-95EA-EF1410A7106A}" dt="2025-01-24T20:19:57.165" v="2117" actId="20577"/>
        <pc:sldMkLst>
          <pc:docMk/>
          <pc:sldMk cId="1609219018" sldId="275"/>
        </pc:sldMkLst>
      </pc:sldChg>
      <pc:sldChg chg="addSp delSp modSp add mod">
        <pc:chgData name="Dana El Soufi El Sabbagh" userId="74de5ba5-1dc9-4933-9dda-791d435de68e" providerId="ADAL" clId="{1042A9DD-6DD8-8142-95EA-EF1410A7106A}" dt="2025-01-22T02:05:09.946" v="1804" actId="20577"/>
        <pc:sldMkLst>
          <pc:docMk/>
          <pc:sldMk cId="3281206061" sldId="276"/>
        </pc:sldMkLst>
      </pc:sldChg>
      <pc:sldChg chg="addSp delSp modSp new mod">
        <pc:chgData name="Dana El Soufi El Sabbagh" userId="74de5ba5-1dc9-4933-9dda-791d435de68e" providerId="ADAL" clId="{1042A9DD-6DD8-8142-95EA-EF1410A7106A}" dt="2025-01-22T01:24:22.152" v="1558" actId="20577"/>
        <pc:sldMkLst>
          <pc:docMk/>
          <pc:sldMk cId="2933273349" sldId="277"/>
        </pc:sldMkLst>
      </pc:sldChg>
    </pc:docChg>
  </pc:docChgLst>
  <pc:docChgLst>
    <pc:chgData name="Dana El Soufi El Sabbagh" userId="74de5ba5-1dc9-4933-9dda-791d435de68e" providerId="ADAL" clId="{D7360E56-8056-3848-B17F-6D7117481306}"/>
    <pc:docChg chg="delSld">
      <pc:chgData name="Dana El Soufi El Sabbagh" userId="74de5ba5-1dc9-4933-9dda-791d435de68e" providerId="ADAL" clId="{D7360E56-8056-3848-B17F-6D7117481306}" dt="2025-07-14T17:58:37.302" v="0" actId="2696"/>
      <pc:docMkLst>
        <pc:docMk/>
      </pc:docMkLst>
      <pc:sldChg chg="del">
        <pc:chgData name="Dana El Soufi El Sabbagh" userId="74de5ba5-1dc9-4933-9dda-791d435de68e" providerId="ADAL" clId="{D7360E56-8056-3848-B17F-6D7117481306}" dt="2025-07-14T17:58:37.302" v="0" actId="2696"/>
        <pc:sldMkLst>
          <pc:docMk/>
          <pc:sldMk cId="510769801" sldId="284"/>
        </pc:sldMkLst>
      </pc:sldChg>
    </pc:docChg>
  </pc:docChgLst>
  <pc:docChgLst>
    <pc:chgData name="Dana El Soufi El Sabbagh" userId="74de5ba5-1dc9-4933-9dda-791d435de68e" providerId="ADAL" clId="{3C2477C9-FD65-BE4B-94C0-A79F9F2E26AE}"/>
    <pc:docChg chg="undo custSel addSld delSld modSld">
      <pc:chgData name="Dana El Soufi El Sabbagh" userId="74de5ba5-1dc9-4933-9dda-791d435de68e" providerId="ADAL" clId="{3C2477C9-FD65-BE4B-94C0-A79F9F2E26AE}" dt="2025-04-22T03:49:56.510" v="6" actId="2696"/>
      <pc:docMkLst>
        <pc:docMk/>
      </pc:docMkLst>
      <pc:sldChg chg="modSp mod">
        <pc:chgData name="Dana El Soufi El Sabbagh" userId="74de5ba5-1dc9-4933-9dda-791d435de68e" providerId="ADAL" clId="{3C2477C9-FD65-BE4B-94C0-A79F9F2E26AE}" dt="2025-04-22T03:45:09.838" v="5" actId="1076"/>
        <pc:sldMkLst>
          <pc:docMk/>
          <pc:sldMk cId="3281206061" sldId="276"/>
        </pc:sldMkLst>
      </pc:sldChg>
      <pc:sldChg chg="modSp mod">
        <pc:chgData name="Dana El Soufi El Sabbagh" userId="74de5ba5-1dc9-4933-9dda-791d435de68e" providerId="ADAL" clId="{3C2477C9-FD65-BE4B-94C0-A79F9F2E26AE}" dt="2025-04-22T03:34:20.089" v="1" actId="1076"/>
        <pc:sldMkLst>
          <pc:docMk/>
          <pc:sldMk cId="3405084103" sldId="282"/>
        </pc:sldMkLst>
      </pc:sldChg>
      <pc:sldChg chg="delSp add del mod">
        <pc:chgData name="Dana El Soufi El Sabbagh" userId="74de5ba5-1dc9-4933-9dda-791d435de68e" providerId="ADAL" clId="{3C2477C9-FD65-BE4B-94C0-A79F9F2E26AE}" dt="2025-04-22T03:49:56.510" v="6" actId="2696"/>
        <pc:sldMkLst>
          <pc:docMk/>
          <pc:sldMk cId="2853258061" sldId="290"/>
        </pc:sldMkLst>
      </pc:sldChg>
    </pc:docChg>
  </pc:docChgLst>
  <pc:docChgLst>
    <pc:chgData name="Dana El Soufi El Sabbagh" userId="74de5ba5-1dc9-4933-9dda-791d435de68e" providerId="ADAL" clId="{C8EC3021-3A39-0145-8445-DE2094C992BF}"/>
    <pc:docChg chg="undo custSel addSld delSld modSld sldOrd">
      <pc:chgData name="Dana El Soufi El Sabbagh" userId="74de5ba5-1dc9-4933-9dda-791d435de68e" providerId="ADAL" clId="{C8EC3021-3A39-0145-8445-DE2094C992BF}" dt="2025-03-08T20:44:50.048" v="3449" actId="2696"/>
      <pc:docMkLst>
        <pc:docMk/>
      </pc:docMkLst>
      <pc:sldChg chg="modSp del mod">
        <pc:chgData name="Dana El Soufi El Sabbagh" userId="74de5ba5-1dc9-4933-9dda-791d435de68e" providerId="ADAL" clId="{C8EC3021-3A39-0145-8445-DE2094C992BF}" dt="2025-03-08T16:48:44.055" v="3161" actId="2696"/>
        <pc:sldMkLst>
          <pc:docMk/>
          <pc:sldMk cId="0" sldId="256"/>
        </pc:sldMkLst>
      </pc:sldChg>
      <pc:sldChg chg="addSp delSp modSp del mod ord">
        <pc:chgData name="Dana El Soufi El Sabbagh" userId="74de5ba5-1dc9-4933-9dda-791d435de68e" providerId="ADAL" clId="{C8EC3021-3A39-0145-8445-DE2094C992BF}" dt="2025-02-06T04:30:03.139" v="2447" actId="2696"/>
        <pc:sldMkLst>
          <pc:docMk/>
          <pc:sldMk cId="0" sldId="257"/>
        </pc:sldMkLst>
      </pc:sldChg>
      <pc:sldChg chg="addSp delSp modSp mod ord">
        <pc:chgData name="Dana El Soufi El Sabbagh" userId="74de5ba5-1dc9-4933-9dda-791d435de68e" providerId="ADAL" clId="{C8EC3021-3A39-0145-8445-DE2094C992BF}" dt="2025-03-08T16:52:35.158" v="3236" actId="20577"/>
        <pc:sldMkLst>
          <pc:docMk/>
          <pc:sldMk cId="0" sldId="258"/>
        </pc:sldMkLst>
      </pc:sldChg>
      <pc:sldChg chg="addSp delSp modSp mod ord">
        <pc:chgData name="Dana El Soufi El Sabbagh" userId="74de5ba5-1dc9-4933-9dda-791d435de68e" providerId="ADAL" clId="{C8EC3021-3A39-0145-8445-DE2094C992BF}" dt="2025-03-08T16:50:59.532" v="3190" actId="20577"/>
        <pc:sldMkLst>
          <pc:docMk/>
          <pc:sldMk cId="0" sldId="259"/>
        </pc:sldMkLst>
      </pc:sldChg>
      <pc:sldChg chg="modSp del mod">
        <pc:chgData name="Dana El Soufi El Sabbagh" userId="74de5ba5-1dc9-4933-9dda-791d435de68e" providerId="ADAL" clId="{C8EC3021-3A39-0145-8445-DE2094C992BF}" dt="2025-02-05T21:40:45.702" v="1643" actId="2696"/>
        <pc:sldMkLst>
          <pc:docMk/>
          <pc:sldMk cId="0" sldId="262"/>
        </pc:sldMkLst>
      </pc:sldChg>
      <pc:sldChg chg="addSp delSp modSp mod">
        <pc:chgData name="Dana El Soufi El Sabbagh" userId="74de5ba5-1dc9-4933-9dda-791d435de68e" providerId="ADAL" clId="{C8EC3021-3A39-0145-8445-DE2094C992BF}" dt="2025-03-08T20:43:37.763" v="3441" actId="255"/>
        <pc:sldMkLst>
          <pc:docMk/>
          <pc:sldMk cId="0" sldId="263"/>
        </pc:sldMkLst>
      </pc:sldChg>
      <pc:sldChg chg="modSp mod">
        <pc:chgData name="Dana El Soufi El Sabbagh" userId="74de5ba5-1dc9-4933-9dda-791d435de68e" providerId="ADAL" clId="{C8EC3021-3A39-0145-8445-DE2094C992BF}" dt="2025-03-08T20:44:23.554" v="3447" actId="255"/>
        <pc:sldMkLst>
          <pc:docMk/>
          <pc:sldMk cId="0" sldId="266"/>
        </pc:sldMkLst>
      </pc:sldChg>
      <pc:sldChg chg="addSp delSp modSp mod">
        <pc:chgData name="Dana El Soufi El Sabbagh" userId="74de5ba5-1dc9-4933-9dda-791d435de68e" providerId="ADAL" clId="{C8EC3021-3A39-0145-8445-DE2094C992BF}" dt="2025-03-08T16:59:35.232" v="3394" actId="20577"/>
        <pc:sldMkLst>
          <pc:docMk/>
          <pc:sldMk cId="0" sldId="270"/>
        </pc:sldMkLst>
      </pc:sldChg>
      <pc:sldChg chg="modSp del mod">
        <pc:chgData name="Dana El Soufi El Sabbagh" userId="74de5ba5-1dc9-4933-9dda-791d435de68e" providerId="ADAL" clId="{C8EC3021-3A39-0145-8445-DE2094C992BF}" dt="2025-03-08T20:44:45.902" v="3448" actId="2696"/>
        <pc:sldMkLst>
          <pc:docMk/>
          <pc:sldMk cId="0" sldId="271"/>
        </pc:sldMkLst>
      </pc:sldChg>
      <pc:sldChg chg="modSp mod ord">
        <pc:chgData name="Dana El Soufi El Sabbagh" userId="74de5ba5-1dc9-4933-9dda-791d435de68e" providerId="ADAL" clId="{C8EC3021-3A39-0145-8445-DE2094C992BF}" dt="2025-03-08T16:50:43.297" v="3188"/>
        <pc:sldMkLst>
          <pc:docMk/>
          <pc:sldMk cId="0" sldId="272"/>
        </pc:sldMkLst>
      </pc:sldChg>
      <pc:sldChg chg="del mod modShow">
        <pc:chgData name="Dana El Soufi El Sabbagh" userId="74de5ba5-1dc9-4933-9dda-791d435de68e" providerId="ADAL" clId="{C8EC3021-3A39-0145-8445-DE2094C992BF}" dt="2025-02-06T04:50:29.876" v="2670" actId="2696"/>
        <pc:sldMkLst>
          <pc:docMk/>
          <pc:sldMk cId="0" sldId="273"/>
        </pc:sldMkLst>
      </pc:sldChg>
      <pc:sldChg chg="modSp mod">
        <pc:chgData name="Dana El Soufi El Sabbagh" userId="74de5ba5-1dc9-4933-9dda-791d435de68e" providerId="ADAL" clId="{C8EC3021-3A39-0145-8445-DE2094C992BF}" dt="2025-03-08T20:44:06.074" v="3443" actId="20577"/>
        <pc:sldMkLst>
          <pc:docMk/>
          <pc:sldMk cId="1609219018" sldId="275"/>
        </pc:sldMkLst>
      </pc:sldChg>
      <pc:sldChg chg="addSp delSp modSp mod">
        <pc:chgData name="Dana El Soufi El Sabbagh" userId="74de5ba5-1dc9-4933-9dda-791d435de68e" providerId="ADAL" clId="{C8EC3021-3A39-0145-8445-DE2094C992BF}" dt="2025-03-08T16:58:26.084" v="3366" actId="313"/>
        <pc:sldMkLst>
          <pc:docMk/>
          <pc:sldMk cId="3281206061" sldId="276"/>
        </pc:sldMkLst>
      </pc:sldChg>
      <pc:sldChg chg="del">
        <pc:chgData name="Dana El Soufi El Sabbagh" userId="74de5ba5-1dc9-4933-9dda-791d435de68e" providerId="ADAL" clId="{C8EC3021-3A39-0145-8445-DE2094C992BF}" dt="2025-02-06T04:26:58.315" v="2411" actId="2696"/>
        <pc:sldMkLst>
          <pc:docMk/>
          <pc:sldMk cId="2933273349" sldId="277"/>
        </pc:sldMkLst>
      </pc:sldChg>
      <pc:sldChg chg="addSp delSp modSp add del mod">
        <pc:chgData name="Dana El Soufi El Sabbagh" userId="74de5ba5-1dc9-4933-9dda-791d435de68e" providerId="ADAL" clId="{C8EC3021-3A39-0145-8445-DE2094C992BF}" dt="2025-02-05T22:42:55.426" v="2026" actId="2696"/>
        <pc:sldMkLst>
          <pc:docMk/>
          <pc:sldMk cId="209788712" sldId="278"/>
        </pc:sldMkLst>
      </pc:sldChg>
      <pc:sldChg chg="addSp delSp modSp new del mod">
        <pc:chgData name="Dana El Soufi El Sabbagh" userId="74de5ba5-1dc9-4933-9dda-791d435de68e" providerId="ADAL" clId="{C8EC3021-3A39-0145-8445-DE2094C992BF}" dt="2025-02-05T21:20:09.352" v="772" actId="2696"/>
        <pc:sldMkLst>
          <pc:docMk/>
          <pc:sldMk cId="852795033" sldId="278"/>
        </pc:sldMkLst>
      </pc:sldChg>
      <pc:sldChg chg="addSp modSp add del mod">
        <pc:chgData name="Dana El Soufi El Sabbagh" userId="74de5ba5-1dc9-4933-9dda-791d435de68e" providerId="ADAL" clId="{C8EC3021-3A39-0145-8445-DE2094C992BF}" dt="2025-02-05T21:12:35.764" v="655" actId="2696"/>
        <pc:sldMkLst>
          <pc:docMk/>
          <pc:sldMk cId="2207186201" sldId="279"/>
        </pc:sldMkLst>
      </pc:sldChg>
      <pc:sldChg chg="addSp delSp modSp add del mod">
        <pc:chgData name="Dana El Soufi El Sabbagh" userId="74de5ba5-1dc9-4933-9dda-791d435de68e" providerId="ADAL" clId="{C8EC3021-3A39-0145-8445-DE2094C992BF}" dt="2025-02-05T21:19:14.283" v="754" actId="2696"/>
        <pc:sldMkLst>
          <pc:docMk/>
          <pc:sldMk cId="3125987239" sldId="280"/>
        </pc:sldMkLst>
      </pc:sldChg>
      <pc:sldChg chg="addSp delSp modSp add mod">
        <pc:chgData name="Dana El Soufi El Sabbagh" userId="74de5ba5-1dc9-4933-9dda-791d435de68e" providerId="ADAL" clId="{C8EC3021-3A39-0145-8445-DE2094C992BF}" dt="2025-03-08T20:43:27.781" v="3438" actId="255"/>
        <pc:sldMkLst>
          <pc:docMk/>
          <pc:sldMk cId="1056035362" sldId="281"/>
        </pc:sldMkLst>
      </pc:sldChg>
      <pc:sldChg chg="addSp delSp modSp add mod modNotesTx">
        <pc:chgData name="Dana El Soufi El Sabbagh" userId="74de5ba5-1dc9-4933-9dda-791d435de68e" providerId="ADAL" clId="{C8EC3021-3A39-0145-8445-DE2094C992BF}" dt="2025-03-08T20:43:03.803" v="3435" actId="255"/>
        <pc:sldMkLst>
          <pc:docMk/>
          <pc:sldMk cId="3405084103" sldId="282"/>
        </pc:sldMkLst>
      </pc:sldChg>
      <pc:sldChg chg="addSp delSp modSp new mod ord">
        <pc:chgData name="Dana El Soufi El Sabbagh" userId="74de5ba5-1dc9-4933-9dda-791d435de68e" providerId="ADAL" clId="{C8EC3021-3A39-0145-8445-DE2094C992BF}" dt="2025-02-26T01:53:57.838" v="3153" actId="20577"/>
        <pc:sldMkLst>
          <pc:docMk/>
          <pc:sldMk cId="1564578557" sldId="283"/>
        </pc:sldMkLst>
      </pc:sldChg>
      <pc:sldChg chg="addSp delSp modSp new mod">
        <pc:chgData name="Dana El Soufi El Sabbagh" userId="74de5ba5-1dc9-4933-9dda-791d435de68e" providerId="ADAL" clId="{C8EC3021-3A39-0145-8445-DE2094C992BF}" dt="2025-03-08T16:49:16.769" v="3177" actId="20577"/>
        <pc:sldMkLst>
          <pc:docMk/>
          <pc:sldMk cId="510769801" sldId="284"/>
        </pc:sldMkLst>
      </pc:sldChg>
      <pc:sldChg chg="addSp delSp modSp new del mod">
        <pc:chgData name="Dana El Soufi El Sabbagh" userId="74de5ba5-1dc9-4933-9dda-791d435de68e" providerId="ADAL" clId="{C8EC3021-3A39-0145-8445-DE2094C992BF}" dt="2025-02-06T04:27:28.561" v="2415" actId="2696"/>
        <pc:sldMkLst>
          <pc:docMk/>
          <pc:sldMk cId="2074265353" sldId="284"/>
        </pc:sldMkLst>
      </pc:sldChg>
      <pc:sldChg chg="addSp delSp modSp new del mod">
        <pc:chgData name="Dana El Soufi El Sabbagh" userId="74de5ba5-1dc9-4933-9dda-791d435de68e" providerId="ADAL" clId="{C8EC3021-3A39-0145-8445-DE2094C992BF}" dt="2025-02-05T21:12:28.112" v="654" actId="2696"/>
        <pc:sldMkLst>
          <pc:docMk/>
          <pc:sldMk cId="3353577892" sldId="284"/>
        </pc:sldMkLst>
      </pc:sldChg>
      <pc:sldChg chg="addSp delSp modSp new del mod">
        <pc:chgData name="Dana El Soufi El Sabbagh" userId="74de5ba5-1dc9-4933-9dda-791d435de68e" providerId="ADAL" clId="{C8EC3021-3A39-0145-8445-DE2094C992BF}" dt="2025-02-05T22:30:32.605" v="1851" actId="2696"/>
        <pc:sldMkLst>
          <pc:docMk/>
          <pc:sldMk cId="3775855927" sldId="284"/>
        </pc:sldMkLst>
      </pc:sldChg>
      <pc:sldChg chg="addSp delSp modSp new del mod">
        <pc:chgData name="Dana El Soufi El Sabbagh" userId="74de5ba5-1dc9-4933-9dda-791d435de68e" providerId="ADAL" clId="{C8EC3021-3A39-0145-8445-DE2094C992BF}" dt="2025-03-08T20:44:50.048" v="3449" actId="2696"/>
        <pc:sldMkLst>
          <pc:docMk/>
          <pc:sldMk cId="3094551035" sldId="285"/>
        </pc:sldMkLst>
      </pc:sldChg>
      <pc:sldChg chg="addSp delSp modSp new mod">
        <pc:chgData name="Dana El Soufi El Sabbagh" userId="74de5ba5-1dc9-4933-9dda-791d435de68e" providerId="ADAL" clId="{C8EC3021-3A39-0145-8445-DE2094C992BF}" dt="2025-02-06T16:13:20.819" v="2693" actId="113"/>
        <pc:sldMkLst>
          <pc:docMk/>
          <pc:sldMk cId="1477581426" sldId="286"/>
        </pc:sldMkLst>
      </pc:sldChg>
      <pc:sldChg chg="delSp modSp add del mod">
        <pc:chgData name="Dana El Soufi El Sabbagh" userId="74de5ba5-1dc9-4933-9dda-791d435de68e" providerId="ADAL" clId="{C8EC3021-3A39-0145-8445-DE2094C992BF}" dt="2025-02-06T04:41:03.934" v="2645" actId="2696"/>
        <pc:sldMkLst>
          <pc:docMk/>
          <pc:sldMk cId="3249100395" sldId="287"/>
        </pc:sldMkLst>
      </pc:sldChg>
      <pc:sldChg chg="addSp delSp modSp new mod">
        <pc:chgData name="Dana El Soufi El Sabbagh" userId="74de5ba5-1dc9-4933-9dda-791d435de68e" providerId="ADAL" clId="{C8EC3021-3A39-0145-8445-DE2094C992BF}" dt="2025-02-06T16:13:30.587" v="2696" actId="20577"/>
        <pc:sldMkLst>
          <pc:docMk/>
          <pc:sldMk cId="3070820528" sldId="288"/>
        </pc:sldMkLst>
      </pc:sldChg>
      <pc:sldChg chg="addSp delSp modSp new mod ord">
        <pc:chgData name="Dana El Soufi El Sabbagh" userId="74de5ba5-1dc9-4933-9dda-791d435de68e" providerId="ADAL" clId="{C8EC3021-3A39-0145-8445-DE2094C992BF}" dt="2025-03-08T16:59:54.509" v="3395" actId="20577"/>
        <pc:sldMkLst>
          <pc:docMk/>
          <pc:sldMk cId="795776442" sldId="289"/>
        </pc:sldMkLst>
      </pc:sldChg>
    </pc:docChg>
  </pc:docChgLst>
  <pc:docChgLst>
    <pc:chgData name="alencarkolinski@gmail.com" userId="S::urn:spo:guest#alencarkolinski@gmail.com::" providerId="AD" clId="Web-{3E73E9E6-80AA-7D09-ADAF-6409128F6A2B}"/>
    <pc:docChg chg="modSld">
      <pc:chgData name="alencarkolinski@gmail.com" userId="S::urn:spo:guest#alencarkolinski@gmail.com::" providerId="AD" clId="Web-{3E73E9E6-80AA-7D09-ADAF-6409128F6A2B}" dt="2025-01-24T13:20:17.670" v="19" actId="1076"/>
      <pc:docMkLst>
        <pc:docMk/>
      </pc:docMkLst>
      <pc:sldChg chg="addSp delSp modSp">
        <pc:chgData name="alencarkolinski@gmail.com" userId="S::urn:spo:guest#alencarkolinski@gmail.com::" providerId="AD" clId="Web-{3E73E9E6-80AA-7D09-ADAF-6409128F6A2B}" dt="2025-01-24T13:20:17.670" v="19" actId="1076"/>
        <pc:sldMkLst>
          <pc:docMk/>
          <pc:sldMk cId="0" sldId="273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2182413" y="685800"/>
            <a:ext cx="24939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Google Shape;70;g32dffd83b81_0_9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82813" y="685800"/>
            <a:ext cx="2493962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1" name="Google Shape;71;g32dffd83b81_0_9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Google Shape;208;g32dffd83b81_0_9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82813" y="685800"/>
            <a:ext cx="2493962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09" name="Google Shape;209;g32dffd83b81_0_9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249360" y="4206107"/>
            <a:ext cx="6816600" cy="1646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6777966" y="9119180"/>
            <a:ext cx="4389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6777966" y="9119180"/>
            <a:ext cx="4389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249360" y="870271"/>
            <a:ext cx="6816600" cy="11199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249360" y="2253729"/>
            <a:ext cx="6816600" cy="6681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6777966" y="9119180"/>
            <a:ext cx="4389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249360" y="870271"/>
            <a:ext cx="6816600" cy="11199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249360" y="2253729"/>
            <a:ext cx="3199800" cy="6681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3865920" y="2253729"/>
            <a:ext cx="3199800" cy="6681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6777966" y="9119180"/>
            <a:ext cx="4389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249360" y="870271"/>
            <a:ext cx="6816600" cy="11199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6777966" y="9119180"/>
            <a:ext cx="4389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249360" y="1086507"/>
            <a:ext cx="2246400" cy="14778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249360" y="2717440"/>
            <a:ext cx="2246400" cy="62175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6777966" y="9119180"/>
            <a:ext cx="4389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392200" y="880293"/>
            <a:ext cx="5094300" cy="799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6777966" y="9119180"/>
            <a:ext cx="4389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3657600" y="-244"/>
            <a:ext cx="3657600" cy="100584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12400" y="2411542"/>
            <a:ext cx="3236100" cy="2898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12400" y="5481569"/>
            <a:ext cx="3236100" cy="24153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3951600" y="1415969"/>
            <a:ext cx="3069600" cy="7226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6777966" y="9119180"/>
            <a:ext cx="4389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249360" y="8273124"/>
            <a:ext cx="4799100" cy="11832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6777966" y="9119180"/>
            <a:ext cx="4389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249360" y="2163089"/>
            <a:ext cx="6816600" cy="3839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249360" y="6164351"/>
            <a:ext cx="6816600" cy="2543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6777966" y="9119180"/>
            <a:ext cx="4389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249360" y="870271"/>
            <a:ext cx="6816600" cy="1119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249360" y="2253729"/>
            <a:ext cx="6816600" cy="668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6777966" y="9119180"/>
            <a:ext cx="438900" cy="769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1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4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6"/>
          <p:cNvSpPr txBox="1"/>
          <p:nvPr/>
        </p:nvSpPr>
        <p:spPr>
          <a:xfrm>
            <a:off x="5910450" y="2500059"/>
            <a:ext cx="1071000" cy="1547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2"/>
              </a:solidFill>
            </a:endParaRPr>
          </a:p>
        </p:txBody>
      </p:sp>
      <p:sp>
        <p:nvSpPr>
          <p:cNvPr id="76" name="Google Shape;76;p16"/>
          <p:cNvSpPr txBox="1"/>
          <p:nvPr/>
        </p:nvSpPr>
        <p:spPr>
          <a:xfrm>
            <a:off x="540275" y="6131209"/>
            <a:ext cx="4939800" cy="6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b="1" dirty="0">
                <a:solidFill>
                  <a:schemeClr val="dk1"/>
                </a:solidFill>
              </a:rPr>
              <a:t>Supplementary Figure 1. </a:t>
            </a:r>
            <a:r>
              <a:rPr lang="en" sz="1000" dirty="0">
                <a:solidFill>
                  <a:schemeClr val="dk1"/>
                </a:solidFill>
              </a:rPr>
              <a:t>Data collected from patient plasma. A) Measurement of </a:t>
            </a:r>
            <a:r>
              <a:rPr lang="en" sz="1000" dirty="0" err="1">
                <a:solidFill>
                  <a:schemeClr val="dk1"/>
                </a:solidFill>
              </a:rPr>
              <a:t>ccf</a:t>
            </a:r>
            <a:r>
              <a:rPr lang="en" sz="1000" dirty="0">
                <a:solidFill>
                  <a:schemeClr val="dk1"/>
                </a:solidFill>
              </a:rPr>
              <a:t> </a:t>
            </a:r>
            <a:r>
              <a:rPr lang="en" sz="1000" dirty="0" err="1">
                <a:solidFill>
                  <a:schemeClr val="dk1"/>
                </a:solidFill>
              </a:rPr>
              <a:t>mtDNA</a:t>
            </a:r>
            <a:r>
              <a:rPr lang="en" sz="1000" dirty="0">
                <a:solidFill>
                  <a:schemeClr val="dk1"/>
                </a:solidFill>
              </a:rPr>
              <a:t> (copies/µL) Data analyzed by Welch’s t-test. </a:t>
            </a:r>
            <a:r>
              <a:rPr lang="en-CA" sz="1000" dirty="0">
                <a:solidFill>
                  <a:schemeClr val="dk1"/>
                </a:solidFill>
              </a:rPr>
              <a:t>P</a:t>
            </a:r>
            <a:r>
              <a:rPr lang="en" sz="1000" dirty="0">
                <a:solidFill>
                  <a:schemeClr val="dk1"/>
                </a:solidFill>
              </a:rPr>
              <a:t>=0.16. B) Heatmap of mitochondrial plasma metabolites stratified by disease.</a:t>
            </a:r>
            <a:endParaRPr sz="1000" dirty="0">
              <a:solidFill>
                <a:schemeClr val="dk1"/>
              </a:solidFill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A8BABE09-6BDD-8B72-AF40-E7858E5A9E2A}"/>
              </a:ext>
            </a:extLst>
          </p:cNvPr>
          <p:cNvGrpSpPr/>
          <p:nvPr/>
        </p:nvGrpSpPr>
        <p:grpSpPr>
          <a:xfrm>
            <a:off x="540275" y="328050"/>
            <a:ext cx="2518325" cy="2392858"/>
            <a:chOff x="540275" y="328050"/>
            <a:chExt cx="2518325" cy="2392858"/>
          </a:xfrm>
        </p:grpSpPr>
        <p:pic>
          <p:nvPicPr>
            <p:cNvPr id="73" name="Google Shape;73;p16"/>
            <p:cNvPicPr preferRelativeResize="0"/>
            <p:nvPr/>
          </p:nvPicPr>
          <p:blipFill>
            <a:blip r:embed="rId3">
              <a:alphaModFix/>
            </a:blip>
            <a:stretch>
              <a:fillRect/>
            </a:stretch>
          </p:blipFill>
          <p:spPr>
            <a:xfrm>
              <a:off x="1059275" y="466358"/>
              <a:ext cx="1999325" cy="225455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77" name="Google Shape;77;p16"/>
            <p:cNvSpPr txBox="1"/>
            <p:nvPr/>
          </p:nvSpPr>
          <p:spPr>
            <a:xfrm>
              <a:off x="540275" y="328050"/>
              <a:ext cx="519000" cy="4311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1600" b="1">
                  <a:solidFill>
                    <a:schemeClr val="dk1"/>
                  </a:solidFill>
                </a:rPr>
                <a:t>A</a:t>
              </a:r>
              <a:endParaRPr sz="1600" b="1">
                <a:solidFill>
                  <a:schemeClr val="dk1"/>
                </a:solidFill>
              </a:endParaRP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A0AE1644-E8A7-86F1-94BA-1AE5B91486AD}"/>
              </a:ext>
            </a:extLst>
          </p:cNvPr>
          <p:cNvGrpSpPr/>
          <p:nvPr/>
        </p:nvGrpSpPr>
        <p:grpSpPr>
          <a:xfrm>
            <a:off x="540275" y="3250326"/>
            <a:ext cx="4131128" cy="2757925"/>
            <a:chOff x="540275" y="2396050"/>
            <a:chExt cx="4131128" cy="2757925"/>
          </a:xfrm>
        </p:grpSpPr>
        <p:pic>
          <p:nvPicPr>
            <p:cNvPr id="74" name="Google Shape;74;p16"/>
            <p:cNvPicPr preferRelativeResize="0"/>
            <p:nvPr/>
          </p:nvPicPr>
          <p:blipFill>
            <a:blip r:embed="rId4">
              <a:alphaModFix/>
            </a:blip>
            <a:srcRect t="5201"/>
            <a:stretch/>
          </p:blipFill>
          <p:spPr>
            <a:xfrm>
              <a:off x="635927" y="2729752"/>
              <a:ext cx="4035476" cy="242422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78" name="Google Shape;78;p16"/>
            <p:cNvSpPr txBox="1"/>
            <p:nvPr/>
          </p:nvSpPr>
          <p:spPr>
            <a:xfrm>
              <a:off x="540275" y="2396050"/>
              <a:ext cx="519000" cy="4311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1600" b="1">
                  <a:solidFill>
                    <a:schemeClr val="dk1"/>
                  </a:solidFill>
                </a:rPr>
                <a:t>B</a:t>
              </a:r>
              <a:endParaRPr sz="1600" b="1">
                <a:solidFill>
                  <a:schemeClr val="dk1"/>
                </a:solidFill>
              </a:endParaRP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16DFCF82-DE58-8523-4F45-FCC55F849646}"/>
              </a:ext>
            </a:extLst>
          </p:cNvPr>
          <p:cNvGrpSpPr/>
          <p:nvPr/>
        </p:nvGrpSpPr>
        <p:grpSpPr>
          <a:xfrm>
            <a:off x="392907" y="565008"/>
            <a:ext cx="3643884" cy="2655364"/>
            <a:chOff x="4176449" y="528237"/>
            <a:chExt cx="2662188" cy="2303721"/>
          </a:xfrm>
        </p:grpSpPr>
        <p:pic>
          <p:nvPicPr>
            <p:cNvPr id="4" name="Picture 3" descr="A group of images of different sizes of human cells&#10;&#10;AI-generated content may be incorrect.">
              <a:extLst>
                <a:ext uri="{FF2B5EF4-FFF2-40B4-BE49-F238E27FC236}">
                  <a16:creationId xmlns:a16="http://schemas.microsoft.com/office/drawing/2014/main" id="{1C1925C3-6372-678C-D392-AFBF7233ED1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176449" y="1903202"/>
              <a:ext cx="1296000" cy="928756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5" name="Picture 4" descr="A group of x-rays of a human body&#10;&#10;AI-generated content may be incorrect.">
              <a:extLst>
                <a:ext uri="{FF2B5EF4-FFF2-40B4-BE49-F238E27FC236}">
                  <a16:creationId xmlns:a16="http://schemas.microsoft.com/office/drawing/2014/main" id="{EAEB909C-E6BE-FB8A-EFC8-E9E7545A62C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483249" y="1903202"/>
              <a:ext cx="1355388" cy="928756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5AB0062-C113-C526-BF98-F824A324D260}"/>
                </a:ext>
              </a:extLst>
            </p:cNvPr>
            <p:cNvSpPr txBox="1"/>
            <p:nvPr/>
          </p:nvSpPr>
          <p:spPr>
            <a:xfrm>
              <a:off x="4631488" y="1718535"/>
              <a:ext cx="4219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BD004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3459CD0-1506-BA5F-E035-F97A69A9B755}"/>
                </a:ext>
              </a:extLst>
            </p:cNvPr>
            <p:cNvSpPr txBox="1"/>
            <p:nvPr/>
          </p:nvSpPr>
          <p:spPr>
            <a:xfrm>
              <a:off x="5927488" y="1718535"/>
              <a:ext cx="4219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BD008</a:t>
              </a:r>
            </a:p>
          </p:txBody>
        </p:sp>
        <p:pic>
          <p:nvPicPr>
            <p:cNvPr id="8" name="Picture 7" descr="A group of images of a bear&#10;&#10;AI-generated content may be incorrect.">
              <a:extLst>
                <a:ext uri="{FF2B5EF4-FFF2-40B4-BE49-F238E27FC236}">
                  <a16:creationId xmlns:a16="http://schemas.microsoft.com/office/drawing/2014/main" id="{610D573E-9B7F-468E-C8D5-69587E078DD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196582" y="712903"/>
              <a:ext cx="1296001" cy="936762"/>
            </a:xfrm>
            <a:prstGeom prst="rect">
              <a:avLst/>
            </a:prstGeom>
            <a:ln w="22225">
              <a:solidFill>
                <a:schemeClr val="tx1"/>
              </a:solidFill>
            </a:ln>
          </p:spPr>
        </p:pic>
        <p:pic>
          <p:nvPicPr>
            <p:cNvPr id="9" name="Picture 8" descr="A group of x-rays of a cell&#10;&#10;AI-generated content may be incorrect.">
              <a:extLst>
                <a:ext uri="{FF2B5EF4-FFF2-40B4-BE49-F238E27FC236}">
                  <a16:creationId xmlns:a16="http://schemas.microsoft.com/office/drawing/2014/main" id="{1068DA5F-ABD0-E079-DB73-841A5DBF537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512716" y="712903"/>
              <a:ext cx="1325921" cy="943810"/>
            </a:xfrm>
            <a:prstGeom prst="rect">
              <a:avLst/>
            </a:prstGeom>
            <a:ln w="22225">
              <a:solidFill>
                <a:schemeClr val="tx1"/>
              </a:solidFill>
            </a:ln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4777912-937B-4FB1-7CCC-97AFEAF7F4B4}"/>
                </a:ext>
              </a:extLst>
            </p:cNvPr>
            <p:cNvSpPr txBox="1"/>
            <p:nvPr/>
          </p:nvSpPr>
          <p:spPr>
            <a:xfrm>
              <a:off x="4633886" y="528237"/>
              <a:ext cx="41710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CT001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F71BBED-770A-AECD-B1EB-CB8EED7C65CB}"/>
                </a:ext>
              </a:extLst>
            </p:cNvPr>
            <p:cNvSpPr txBox="1"/>
            <p:nvPr/>
          </p:nvSpPr>
          <p:spPr>
            <a:xfrm>
              <a:off x="5929886" y="528237"/>
              <a:ext cx="41710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CT006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BD9EC0D8-A719-A67D-C394-C3EE327CFAD8}"/>
              </a:ext>
            </a:extLst>
          </p:cNvPr>
          <p:cNvSpPr txBox="1"/>
          <p:nvPr/>
        </p:nvSpPr>
        <p:spPr>
          <a:xfrm>
            <a:off x="305312" y="3323304"/>
            <a:ext cx="5786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2</a:t>
            </a:r>
            <a:r>
              <a:rPr lang="en-US" sz="1200" dirty="0"/>
              <a:t>. Abnormal karyotyping of additional participants  </a:t>
            </a:r>
          </a:p>
        </p:txBody>
      </p:sp>
    </p:spTree>
    <p:extLst>
      <p:ext uri="{BB962C8B-B14F-4D97-AF65-F5344CB8AC3E}">
        <p14:creationId xmlns:p14="http://schemas.microsoft.com/office/powerpoint/2010/main" val="15645785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1" name="Google Shape;211;p29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0" y="423820"/>
            <a:ext cx="7010401" cy="1720145"/>
          </a:xfrm>
          <a:prstGeom prst="rect">
            <a:avLst/>
          </a:prstGeom>
          <a:noFill/>
          <a:ln>
            <a:noFill/>
          </a:ln>
        </p:spPr>
      </p:pic>
      <p:sp>
        <p:nvSpPr>
          <p:cNvPr id="212" name="Google Shape;212;p29"/>
          <p:cNvSpPr txBox="1"/>
          <p:nvPr/>
        </p:nvSpPr>
        <p:spPr>
          <a:xfrm>
            <a:off x="273917" y="9414577"/>
            <a:ext cx="7018719" cy="408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100" b="1" dirty="0">
                <a:solidFill>
                  <a:schemeClr val="tx1"/>
                </a:solidFill>
              </a:rPr>
              <a:t>Supplementary Figure 3. </a:t>
            </a:r>
            <a:r>
              <a:rPr lang="en" sz="1100" dirty="0">
                <a:solidFill>
                  <a:schemeClr val="tx1"/>
                </a:solidFill>
              </a:rPr>
              <a:t>Additional CO staining. A) TOMM20, dsDNA, MAP2 markers in 1 month old </a:t>
            </a:r>
            <a:r>
              <a:rPr lang="en" sz="1100" dirty="0" err="1">
                <a:solidFill>
                  <a:schemeClr val="tx1"/>
                </a:solidFill>
              </a:rPr>
              <a:t>COs.</a:t>
            </a:r>
            <a:r>
              <a:rPr lang="en" sz="1100" dirty="0">
                <a:solidFill>
                  <a:schemeClr val="tx1"/>
                </a:solidFill>
              </a:rPr>
              <a:t> Scale bar = 10</a:t>
            </a:r>
            <a:r>
              <a:rPr lang="en-CA" sz="11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sym typeface="Symbol" pitchFamily="2" charset="2"/>
              </a:rPr>
              <a:t> </a:t>
            </a:r>
            <a:r>
              <a:rPr lang="en" sz="1100" dirty="0">
                <a:solidFill>
                  <a:schemeClr val="tx1"/>
                </a:solidFill>
              </a:rPr>
              <a:t>m. B) MAP2, GFAP, VGLUT1 in 6 month old </a:t>
            </a:r>
            <a:r>
              <a:rPr lang="en" sz="1100" dirty="0" err="1">
                <a:solidFill>
                  <a:schemeClr val="tx1"/>
                </a:solidFill>
              </a:rPr>
              <a:t>COs.</a:t>
            </a:r>
            <a:r>
              <a:rPr lang="en" sz="1100" dirty="0">
                <a:solidFill>
                  <a:schemeClr val="tx1"/>
                </a:solidFill>
              </a:rPr>
              <a:t> Scale bar = 50</a:t>
            </a:r>
            <a:r>
              <a:rPr lang="en-CA" sz="11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CA" sz="11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sym typeface="Symbol" pitchFamily="2" charset="2"/>
              </a:rPr>
              <a:t></a:t>
            </a:r>
            <a:r>
              <a:rPr lang="en" sz="1100" dirty="0">
                <a:solidFill>
                  <a:schemeClr val="tx1"/>
                </a:solidFill>
              </a:rPr>
              <a:t>m. C) BRN2 in 6 month old </a:t>
            </a:r>
            <a:r>
              <a:rPr lang="en" sz="1100" dirty="0" err="1">
                <a:solidFill>
                  <a:schemeClr val="tx1"/>
                </a:solidFill>
              </a:rPr>
              <a:t>COs.</a:t>
            </a:r>
            <a:r>
              <a:rPr lang="en" sz="1100" dirty="0">
                <a:solidFill>
                  <a:schemeClr val="tx1"/>
                </a:solidFill>
              </a:rPr>
              <a:t> D) MAP2, VGLUT1, CTIP2 in 6 month old </a:t>
            </a:r>
            <a:r>
              <a:rPr lang="en" sz="1100" dirty="0" err="1">
                <a:solidFill>
                  <a:schemeClr val="tx1"/>
                </a:solidFill>
              </a:rPr>
              <a:t>COs.</a:t>
            </a:r>
            <a:r>
              <a:rPr lang="en" sz="1100" dirty="0">
                <a:solidFill>
                  <a:schemeClr val="tx1"/>
                </a:solidFill>
              </a:rPr>
              <a:t> Scale bar = 50</a:t>
            </a:r>
            <a:r>
              <a:rPr lang="en-CA" sz="11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sym typeface="Symbol" pitchFamily="2" charset="2"/>
              </a:rPr>
              <a:t> </a:t>
            </a:r>
            <a:r>
              <a:rPr lang="en" sz="1100" dirty="0">
                <a:solidFill>
                  <a:schemeClr val="tx1"/>
                </a:solidFill>
              </a:rPr>
              <a:t>m.</a:t>
            </a:r>
            <a:endParaRPr sz="1100" dirty="0">
              <a:solidFill>
                <a:schemeClr val="tx1"/>
              </a:solidFill>
            </a:endParaRPr>
          </a:p>
        </p:txBody>
      </p:sp>
      <p:sp>
        <p:nvSpPr>
          <p:cNvPr id="213" name="Google Shape;213;p29"/>
          <p:cNvSpPr txBox="1"/>
          <p:nvPr/>
        </p:nvSpPr>
        <p:spPr>
          <a:xfrm>
            <a:off x="0" y="9827"/>
            <a:ext cx="867600" cy="782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 b="1">
                <a:solidFill>
                  <a:schemeClr val="dk1"/>
                </a:solidFill>
              </a:rPr>
              <a:t>A</a:t>
            </a:r>
            <a:endParaRPr sz="1800" b="1">
              <a:solidFill>
                <a:schemeClr val="dk1"/>
              </a:solidFill>
            </a:endParaRP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B1579DB5-058C-D57C-C7F7-0054635F8CE4}"/>
              </a:ext>
            </a:extLst>
          </p:cNvPr>
          <p:cNvGrpSpPr/>
          <p:nvPr/>
        </p:nvGrpSpPr>
        <p:grpSpPr>
          <a:xfrm>
            <a:off x="0" y="2012455"/>
            <a:ext cx="6229720" cy="3545458"/>
            <a:chOff x="104133" y="2761339"/>
            <a:chExt cx="6229720" cy="3545458"/>
          </a:xfrm>
        </p:grpSpPr>
        <p:pic>
          <p:nvPicPr>
            <p:cNvPr id="2" name="Picture 1" descr="A collage of different colored spots&#10;&#10;AI-generated content may be incorrect.">
              <a:extLst>
                <a:ext uri="{FF2B5EF4-FFF2-40B4-BE49-F238E27FC236}">
                  <a16:creationId xmlns:a16="http://schemas.microsoft.com/office/drawing/2014/main" id="{C083F128-76B9-56F5-D76F-E7514347DA9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98159" y="3203617"/>
              <a:ext cx="3052104" cy="3052104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CBB1EF8-49CA-0A81-77A4-A1743BEDB71E}"/>
                </a:ext>
              </a:extLst>
            </p:cNvPr>
            <p:cNvSpPr txBox="1"/>
            <p:nvPr/>
          </p:nvSpPr>
          <p:spPr>
            <a:xfrm>
              <a:off x="837653" y="5999020"/>
              <a:ext cx="60465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solidFill>
                    <a:srgbClr val="0070C0"/>
                  </a:solidFill>
                </a:rPr>
                <a:t>DAPI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8D6025D-2D08-12E6-6BAE-BBA0A28EE210}"/>
                </a:ext>
              </a:extLst>
            </p:cNvPr>
            <p:cNvSpPr txBox="1"/>
            <p:nvPr/>
          </p:nvSpPr>
          <p:spPr>
            <a:xfrm>
              <a:off x="2005298" y="5947944"/>
              <a:ext cx="8819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solidFill>
                    <a:schemeClr val="tx2"/>
                  </a:solidFill>
                </a:rPr>
                <a:t>VGLUT1</a:t>
              </a:r>
            </a:p>
          </p:txBody>
        </p:sp>
        <p:pic>
          <p:nvPicPr>
            <p:cNvPr id="3" name="Picture 2" descr="A close-up of blue cells&#10;&#10;AI-generated content may be incorrect.">
              <a:extLst>
                <a:ext uri="{FF2B5EF4-FFF2-40B4-BE49-F238E27FC236}">
                  <a16:creationId xmlns:a16="http://schemas.microsoft.com/office/drawing/2014/main" id="{660213FD-E445-B90B-6FF1-D9837D0D618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657600" y="3476655"/>
              <a:ext cx="2676253" cy="2676253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320D08A-E753-E39F-143C-82C3C2856093}"/>
                </a:ext>
              </a:extLst>
            </p:cNvPr>
            <p:cNvSpPr txBox="1"/>
            <p:nvPr/>
          </p:nvSpPr>
          <p:spPr>
            <a:xfrm>
              <a:off x="803189" y="4421891"/>
              <a:ext cx="6735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solidFill>
                    <a:srgbClr val="FF0000"/>
                  </a:solidFill>
                </a:rPr>
                <a:t>MAP2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07310DC-AF11-904D-D666-A80BC6C5B936}"/>
                </a:ext>
              </a:extLst>
            </p:cNvPr>
            <p:cNvSpPr txBox="1"/>
            <p:nvPr/>
          </p:nvSpPr>
          <p:spPr>
            <a:xfrm>
              <a:off x="2335427" y="4421891"/>
              <a:ext cx="365760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>
                  <a:solidFill>
                    <a:srgbClr val="00B050"/>
                  </a:solidFill>
                </a:rPr>
                <a:t>GFAP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56A0534-CFEE-4197-E01A-8A66424FA334}"/>
                </a:ext>
              </a:extLst>
            </p:cNvPr>
            <p:cNvSpPr txBox="1"/>
            <p:nvPr/>
          </p:nvSpPr>
          <p:spPr>
            <a:xfrm>
              <a:off x="3889757" y="5760017"/>
              <a:ext cx="8435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solidFill>
                    <a:schemeClr val="tx2"/>
                  </a:solidFill>
                </a:rPr>
                <a:t>MERGE</a:t>
              </a:r>
            </a:p>
          </p:txBody>
        </p:sp>
        <p:sp>
          <p:nvSpPr>
            <p:cNvPr id="11" name="Google Shape;213;p29">
              <a:extLst>
                <a:ext uri="{FF2B5EF4-FFF2-40B4-BE49-F238E27FC236}">
                  <a16:creationId xmlns:a16="http://schemas.microsoft.com/office/drawing/2014/main" id="{9DCD0D4E-B93D-0E58-D4A5-7B15BD79919F}"/>
                </a:ext>
              </a:extLst>
            </p:cNvPr>
            <p:cNvSpPr txBox="1"/>
            <p:nvPr/>
          </p:nvSpPr>
          <p:spPr>
            <a:xfrm>
              <a:off x="104133" y="2761339"/>
              <a:ext cx="867600" cy="7824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1800" b="1">
                  <a:solidFill>
                    <a:schemeClr val="dk1"/>
                  </a:solidFill>
                </a:rPr>
                <a:t>B</a:t>
              </a:r>
              <a:endParaRPr sz="1800" b="1">
                <a:solidFill>
                  <a:schemeClr val="dk1"/>
                </a:solidFill>
              </a:endParaRPr>
            </a:p>
          </p:txBody>
        </p:sp>
      </p:grpSp>
      <p:sp>
        <p:nvSpPr>
          <p:cNvPr id="12" name="Google Shape;213;p29">
            <a:extLst>
              <a:ext uri="{FF2B5EF4-FFF2-40B4-BE49-F238E27FC236}">
                <a16:creationId xmlns:a16="http://schemas.microsoft.com/office/drawing/2014/main" id="{E8CB2E4F-1206-D829-53F4-7EDB54473E97}"/>
              </a:ext>
            </a:extLst>
          </p:cNvPr>
          <p:cNvSpPr txBox="1"/>
          <p:nvPr/>
        </p:nvSpPr>
        <p:spPr>
          <a:xfrm>
            <a:off x="0" y="5620198"/>
            <a:ext cx="867600" cy="782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 b="1">
                <a:solidFill>
                  <a:schemeClr val="dk1"/>
                </a:solidFill>
              </a:rPr>
              <a:t>C</a:t>
            </a:r>
            <a:endParaRPr sz="1800" b="1">
              <a:solidFill>
                <a:schemeClr val="dk1"/>
              </a:solidFill>
            </a:endParaRP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26B9C754-4984-AE4F-C0B3-4BB0189C15B7}"/>
              </a:ext>
            </a:extLst>
          </p:cNvPr>
          <p:cNvGrpSpPr/>
          <p:nvPr/>
        </p:nvGrpSpPr>
        <p:grpSpPr>
          <a:xfrm>
            <a:off x="273917" y="7464819"/>
            <a:ext cx="2038739" cy="1949758"/>
            <a:chOff x="435129" y="6728999"/>
            <a:chExt cx="2619006" cy="2619006"/>
          </a:xfrm>
        </p:grpSpPr>
        <p:pic>
          <p:nvPicPr>
            <p:cNvPr id="14" name="Picture 13" descr="A purple and black background&#10;&#10;AI-generated content may be incorrect.">
              <a:extLst>
                <a:ext uri="{FF2B5EF4-FFF2-40B4-BE49-F238E27FC236}">
                  <a16:creationId xmlns:a16="http://schemas.microsoft.com/office/drawing/2014/main" id="{D56176C4-6345-8123-E322-D78C37FB869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35129" y="6728999"/>
              <a:ext cx="2619006" cy="2619006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1E3D616-2608-90B2-B802-23AD9CDC3BCC}"/>
                </a:ext>
              </a:extLst>
            </p:cNvPr>
            <p:cNvSpPr txBox="1"/>
            <p:nvPr/>
          </p:nvSpPr>
          <p:spPr>
            <a:xfrm>
              <a:off x="606736" y="8954427"/>
              <a:ext cx="6639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solidFill>
                    <a:srgbClr val="7030A0"/>
                  </a:solidFill>
                </a:rPr>
                <a:t>BRN2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66185E04-D99E-B2CD-74E3-CBCA5EF5B43B}"/>
                </a:ext>
              </a:extLst>
            </p:cNvPr>
            <p:cNvSpPr txBox="1"/>
            <p:nvPr/>
          </p:nvSpPr>
          <p:spPr>
            <a:xfrm>
              <a:off x="1270700" y="8962622"/>
              <a:ext cx="60465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solidFill>
                    <a:srgbClr val="0070C0"/>
                  </a:solidFill>
                </a:rPr>
                <a:t>DAPI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0FB4DA5D-6EF3-045F-36A6-08D72223540F}"/>
              </a:ext>
            </a:extLst>
          </p:cNvPr>
          <p:cNvGrpSpPr/>
          <p:nvPr/>
        </p:nvGrpSpPr>
        <p:grpSpPr>
          <a:xfrm>
            <a:off x="235645" y="5938766"/>
            <a:ext cx="7021174" cy="1418663"/>
            <a:chOff x="235645" y="5938766"/>
            <a:chExt cx="7021174" cy="1418663"/>
          </a:xfrm>
        </p:grpSpPr>
        <p:pic>
          <p:nvPicPr>
            <p:cNvPr id="6" name="Picture 5" descr="A blue lights in the dark&#10;&#10;AI-generated content may be incorrect.">
              <a:extLst>
                <a:ext uri="{FF2B5EF4-FFF2-40B4-BE49-F238E27FC236}">
                  <a16:creationId xmlns:a16="http://schemas.microsoft.com/office/drawing/2014/main" id="{A81E7942-336A-71D4-E8B5-997E942B9E5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35645" y="5938766"/>
              <a:ext cx="7021174" cy="1386849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17F5C1FD-F070-CC3B-8F79-01E4C5620BFA}"/>
                </a:ext>
              </a:extLst>
            </p:cNvPr>
            <p:cNvSpPr txBox="1"/>
            <p:nvPr/>
          </p:nvSpPr>
          <p:spPr>
            <a:xfrm>
              <a:off x="2123181" y="7125560"/>
              <a:ext cx="4379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>
                  <a:solidFill>
                    <a:srgbClr val="00B050"/>
                  </a:solidFill>
                </a:rPr>
                <a:t>CTIP2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954EBFE8-9D3D-AFAC-9FAF-2ACE79C48FD1}"/>
                </a:ext>
              </a:extLst>
            </p:cNvPr>
            <p:cNvSpPr txBox="1"/>
            <p:nvPr/>
          </p:nvSpPr>
          <p:spPr>
            <a:xfrm>
              <a:off x="3505200" y="7125560"/>
              <a:ext cx="4379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>
                  <a:solidFill>
                    <a:schemeClr val="accent1"/>
                  </a:solidFill>
                </a:rPr>
                <a:t>DAPI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15C97C2F-3670-D00D-BDAD-BFA9A2ADBC65}"/>
                </a:ext>
              </a:extLst>
            </p:cNvPr>
            <p:cNvSpPr txBox="1"/>
            <p:nvPr/>
          </p:nvSpPr>
          <p:spPr>
            <a:xfrm>
              <a:off x="4887219" y="7141644"/>
              <a:ext cx="6096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>
                  <a:solidFill>
                    <a:schemeClr val="accent5">
                      <a:lumMod val="60000"/>
                      <a:lumOff val="40000"/>
                    </a:schemeClr>
                  </a:solidFill>
                </a:rPr>
                <a:t>VGLUT1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C44329B-6A7E-209C-EC20-56B2F80E39E8}"/>
                </a:ext>
              </a:extLst>
            </p:cNvPr>
            <p:cNvSpPr txBox="1"/>
            <p:nvPr/>
          </p:nvSpPr>
          <p:spPr>
            <a:xfrm>
              <a:off x="699056" y="7157374"/>
              <a:ext cx="6096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>
                  <a:solidFill>
                    <a:srgbClr val="FF0000"/>
                  </a:solidFill>
                </a:rPr>
                <a:t>MAP2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87F89B50-0A33-5987-E947-EA291C139000}"/>
                </a:ext>
              </a:extLst>
            </p:cNvPr>
            <p:cNvSpPr txBox="1"/>
            <p:nvPr/>
          </p:nvSpPr>
          <p:spPr>
            <a:xfrm>
              <a:off x="5924920" y="7125559"/>
              <a:ext cx="6096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>
                  <a:solidFill>
                    <a:schemeClr val="tx2">
                      <a:lumMod val="90000"/>
                    </a:schemeClr>
                  </a:solidFill>
                </a:rPr>
                <a:t>MERGE</a:t>
              </a:r>
            </a:p>
          </p:txBody>
        </p:sp>
      </p:grpSp>
      <p:sp>
        <p:nvSpPr>
          <p:cNvPr id="25" name="Google Shape;213;p29">
            <a:extLst>
              <a:ext uri="{FF2B5EF4-FFF2-40B4-BE49-F238E27FC236}">
                <a16:creationId xmlns:a16="http://schemas.microsoft.com/office/drawing/2014/main" id="{C52E2D8D-FF43-2216-278A-65D3B6C43BCA}"/>
              </a:ext>
            </a:extLst>
          </p:cNvPr>
          <p:cNvSpPr txBox="1"/>
          <p:nvPr/>
        </p:nvSpPr>
        <p:spPr>
          <a:xfrm>
            <a:off x="-26297" y="7342721"/>
            <a:ext cx="867600" cy="782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 b="1">
                <a:solidFill>
                  <a:schemeClr val="dk1"/>
                </a:solidFill>
              </a:rPr>
              <a:t>D</a:t>
            </a:r>
            <a:endParaRPr sz="1800" b="1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9</TotalTime>
  <Words>151</Words>
  <Application>Microsoft Macintosh PowerPoint</Application>
  <PresentationFormat>Custom</PresentationFormat>
  <Paragraphs>25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5" baseType="lpstr">
      <vt:lpstr>Arial</vt:lpstr>
      <vt:lpstr>Simple Light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cp:lastModifiedBy>Dana El Soufi El Sabbagh</cp:lastModifiedBy>
  <cp:revision>1</cp:revision>
  <dcterms:modified xsi:type="dcterms:W3CDTF">2025-07-14T17:58:40Z</dcterms:modified>
</cp:coreProperties>
</file>